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>
        <p:scale>
          <a:sx n="150" d="100"/>
          <a:sy n="150" d="100"/>
        </p:scale>
        <p:origin x="-1886" y="-14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6C3D6-F6ED-163E-D063-6CEF09CC6B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BCB11B-A811-98B9-B7F3-C6C55B48BF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8D5BD6-F97E-5969-2B34-F2027E66E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37915E-25D3-E881-212D-B40C1C201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0ECAB5-B9E4-05CF-DC5C-7F708FAAF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0671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4CB324-5209-360B-DD7C-8267E679D4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7B8366-E0E7-3386-2424-E7E188EC78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02070A-EDE0-2D8E-FD30-C157EE45D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AE6EC8-69AD-F873-116C-6127C1C32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71724C-163A-E95D-5E3F-D9EE40ADF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59798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4C58F0F-9AF7-4CFD-52B8-F2FBD71386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4D1360-2B01-4052-EF6E-6EBFAE29FD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3F2E82-6CAE-CAE1-E7F6-83F552039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E1A5C4-582D-9863-FC77-170BB4E3B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285741-68B4-21C8-EC60-AFD5CE566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88535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C905F-CC37-2F89-DD03-CD2602D37F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71FB2A-33EE-1148-A132-0239713234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3F2857-90A1-3406-16AB-AA837DA81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F8F270-740F-FB9A-7C1A-99C1466BB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0E8DAB-BCCD-ACD4-837A-3A599360F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0858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CABC6F-8576-0547-E80E-0B6B024665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7272D8-FABF-2640-9513-025CD3D3A8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DAC944-3113-5882-27D8-5BBF482DE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607F66-BFC3-D027-34E7-3EB5DD6130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74248-45D5-1D43-0370-3E3D69E9D6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64625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A207AA-C35E-6EC6-AE65-E0957C786B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AA1A5B-1FD0-9E6D-E840-7BA77875F8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101FA6-3123-CFDE-B18F-23DA1B2C5D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F2BC62-4A47-CBD5-52E6-AA780C0DC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7C2B2D-21C7-ED6C-60F1-8043C5A26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2A6629-3702-A181-C91E-2A453E0FEF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6667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56FF0-55A0-AB9B-63B1-813B1819BF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C72E33-C92E-A205-A8EB-4E25B1B82B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7E1A1E-EADF-4D2E-FF54-BF8B66283D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C5A34E-6501-2135-00D0-934674D454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28DD68D-6716-A6E9-5548-85708F8AA2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1A2AA1-919F-91B3-F897-DB057A3D2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9653892-8CF4-F867-9499-63D1E0728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18E305-B62B-04C1-7BCD-6056D20DD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56505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13E1F9-B0E7-CE13-E1FA-C3660CA92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352DA8E-792C-3227-631F-08100AD30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C4C277A-A44F-6262-4EF0-3D35F0C32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20576A6-39ED-BAF1-4A8C-FDE9D18F2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75383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8B3E32-3EB6-160D-ACF7-158DD8C64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16BE387-C2C6-A338-3966-01D6E3629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F028C53-3A87-6852-94A9-594A0166CE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8163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76236D-117B-6E70-3FBF-2285232325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40084F-9530-EFD7-A1F4-1C71C754B8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AFEBEA-E546-9FD6-C4DB-03CDF0B591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9882EC-6BF5-042E-C270-86871EC30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AEF42B-6E37-5E76-CFC1-43A8F53EB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027FC1-481C-3F43-76D8-012A85588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35949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55841D-3824-4BA6-F089-35CED59432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6163992-876C-011B-CDD9-9CBC3840DB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24993B-6CBE-E377-C77A-CC46490CE7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48CAC6-AA5F-C216-CBCA-89469747E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164E61-056D-B7FF-9492-DE0452E400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F49383-B4C4-86FE-7142-BD146A9616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0520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AB034F-7F8B-CC25-BD14-509E90CAD3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603DB4-9E6D-DF12-CA13-9E163D8CD9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B420B0-D5D1-C486-4AD1-3E58E54F4F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C79D1-8645-48E8-A5D7-396D60784406}" type="datetimeFigureOut">
              <a:rPr lang="en-IN" smtClean="0"/>
              <a:t>30-09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D3F2DC-F682-7D10-CD3A-653176E8B7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5072AD-94E0-B7E2-CE21-C1661B8585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D58EF-7EF5-43C2-941E-C6BF0ED6BEC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00476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A774751-1A7A-2863-D8A4-9EE7439F2D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4439" y="1155279"/>
            <a:ext cx="3419388" cy="22737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B18FA74-6BA5-4C42-9D03-36474675A19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4296" y="1179085"/>
            <a:ext cx="3411704" cy="22499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0DA72BB-6104-FD79-0622-C3171BDDB8F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6022" y="3469018"/>
            <a:ext cx="3419978" cy="22499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753A8B6-2DEE-899D-5DEA-93B4AE4878C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4440" y="3469018"/>
            <a:ext cx="3419388" cy="22499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FCAD785-D06A-F735-7B44-A17F468CC226}"/>
              </a:ext>
            </a:extLst>
          </p:cNvPr>
          <p:cNvSpPr txBox="1"/>
          <p:nvPr/>
        </p:nvSpPr>
        <p:spPr>
          <a:xfrm>
            <a:off x="2676022" y="3006037"/>
            <a:ext cx="446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85D998-84D8-A899-8DB9-78E888D971E7}"/>
              </a:ext>
            </a:extLst>
          </p:cNvPr>
          <p:cNvSpPr txBox="1"/>
          <p:nvPr/>
        </p:nvSpPr>
        <p:spPr>
          <a:xfrm>
            <a:off x="6037402" y="3038974"/>
            <a:ext cx="666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354732C-159B-D678-0D47-2A04B1C72E09}"/>
              </a:ext>
            </a:extLst>
          </p:cNvPr>
          <p:cNvSpPr txBox="1"/>
          <p:nvPr/>
        </p:nvSpPr>
        <p:spPr>
          <a:xfrm>
            <a:off x="2647510" y="5328025"/>
            <a:ext cx="446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53E6D68-97D2-0E96-F33B-CA04E19C1525}"/>
              </a:ext>
            </a:extLst>
          </p:cNvPr>
          <p:cNvSpPr txBox="1"/>
          <p:nvPr/>
        </p:nvSpPr>
        <p:spPr>
          <a:xfrm>
            <a:off x="6170391" y="5310381"/>
            <a:ext cx="446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9E46E303-05BC-C88F-268A-5ED90E4DA58B}"/>
              </a:ext>
            </a:extLst>
          </p:cNvPr>
          <p:cNvCxnSpPr>
            <a:cxnSpLocks/>
          </p:cNvCxnSpPr>
          <p:nvPr/>
        </p:nvCxnSpPr>
        <p:spPr>
          <a:xfrm rot="7800000" flipV="1">
            <a:off x="4127781" y="1995089"/>
            <a:ext cx="200891" cy="16842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319361A0-50F0-D06A-BB91-ECDC11161691}"/>
              </a:ext>
            </a:extLst>
          </p:cNvPr>
          <p:cNvCxnSpPr>
            <a:cxnSpLocks/>
          </p:cNvCxnSpPr>
          <p:nvPr/>
        </p:nvCxnSpPr>
        <p:spPr>
          <a:xfrm flipH="1">
            <a:off x="7785726" y="1753477"/>
            <a:ext cx="175495" cy="19474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2B683B0-F290-A3E5-1472-2931E7C87109}"/>
              </a:ext>
            </a:extLst>
          </p:cNvPr>
          <p:cNvCxnSpPr>
            <a:cxnSpLocks/>
          </p:cNvCxnSpPr>
          <p:nvPr/>
        </p:nvCxnSpPr>
        <p:spPr>
          <a:xfrm rot="12780000" flipV="1">
            <a:off x="4312635" y="2224205"/>
            <a:ext cx="200891" cy="16842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87576E2F-0381-8C88-E4AD-242BB34F2696}"/>
              </a:ext>
            </a:extLst>
          </p:cNvPr>
          <p:cNvCxnSpPr>
            <a:cxnSpLocks/>
          </p:cNvCxnSpPr>
          <p:nvPr/>
        </p:nvCxnSpPr>
        <p:spPr>
          <a:xfrm flipV="1">
            <a:off x="4099149" y="2359680"/>
            <a:ext cx="1" cy="24510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B955AADC-0308-35F2-63CE-2EA5D229CF68}"/>
              </a:ext>
            </a:extLst>
          </p:cNvPr>
          <p:cNvCxnSpPr>
            <a:cxnSpLocks/>
          </p:cNvCxnSpPr>
          <p:nvPr/>
        </p:nvCxnSpPr>
        <p:spPr>
          <a:xfrm rot="3540000" flipV="1">
            <a:off x="3745255" y="2145993"/>
            <a:ext cx="200891" cy="16842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9C1592E3-E950-639C-A48A-CF819D72ED1E}"/>
              </a:ext>
            </a:extLst>
          </p:cNvPr>
          <p:cNvCxnSpPr>
            <a:cxnSpLocks/>
          </p:cNvCxnSpPr>
          <p:nvPr/>
        </p:nvCxnSpPr>
        <p:spPr>
          <a:xfrm rot="4500000" flipV="1">
            <a:off x="4075185" y="3727441"/>
            <a:ext cx="200891" cy="16842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1C70352-4045-0F1C-C99D-1BD3FFEDB7A1}"/>
              </a:ext>
            </a:extLst>
          </p:cNvPr>
          <p:cNvCxnSpPr>
            <a:cxnSpLocks/>
          </p:cNvCxnSpPr>
          <p:nvPr/>
        </p:nvCxnSpPr>
        <p:spPr>
          <a:xfrm rot="13500000" flipV="1">
            <a:off x="5081449" y="3927274"/>
            <a:ext cx="200891" cy="16842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5C8F8A1-E23F-6525-EBDA-B6C82205C515}"/>
              </a:ext>
            </a:extLst>
          </p:cNvPr>
          <p:cNvCxnSpPr>
            <a:cxnSpLocks/>
          </p:cNvCxnSpPr>
          <p:nvPr/>
        </p:nvCxnSpPr>
        <p:spPr>
          <a:xfrm flipV="1">
            <a:off x="4769639" y="4265377"/>
            <a:ext cx="1" cy="24510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B077D548-3E8E-2431-543A-4E2D34BA05D4}"/>
              </a:ext>
            </a:extLst>
          </p:cNvPr>
          <p:cNvCxnSpPr>
            <a:cxnSpLocks/>
          </p:cNvCxnSpPr>
          <p:nvPr/>
        </p:nvCxnSpPr>
        <p:spPr>
          <a:xfrm rot="21060000" flipV="1">
            <a:off x="7583500" y="4655514"/>
            <a:ext cx="200891" cy="16842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0AF7EA03-F31E-C717-D4A9-85D99CBBB195}"/>
              </a:ext>
            </a:extLst>
          </p:cNvPr>
          <p:cNvCxnSpPr>
            <a:cxnSpLocks/>
          </p:cNvCxnSpPr>
          <p:nvPr/>
        </p:nvCxnSpPr>
        <p:spPr>
          <a:xfrm rot="9900000" flipV="1">
            <a:off x="4813524" y="3492146"/>
            <a:ext cx="200891" cy="16842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9CCCBA7D-E827-D3C6-2491-B651B259DBD3}"/>
              </a:ext>
            </a:extLst>
          </p:cNvPr>
          <p:cNvSpPr txBox="1"/>
          <p:nvPr/>
        </p:nvSpPr>
        <p:spPr>
          <a:xfrm>
            <a:off x="460076" y="6028682"/>
            <a:ext cx="11368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canning electron microscopy (SEM) analysis of the hyphal interaction betwee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choderm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hytopathogens. (A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choderm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netrating the hyphae of SR; (B) Hyphae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choderm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iling around SR; (C) Hyphae of FOC damaged (arrowhead) by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harzian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(D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harzianu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iling (arrowhead) around the hyphae of FOC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44160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7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njna sharma</dc:creator>
  <cp:lastModifiedBy>Ranjna sharma</cp:lastModifiedBy>
  <cp:revision>3</cp:revision>
  <dcterms:created xsi:type="dcterms:W3CDTF">2025-09-30T07:00:28Z</dcterms:created>
  <dcterms:modified xsi:type="dcterms:W3CDTF">2025-09-30T07:32:46Z</dcterms:modified>
</cp:coreProperties>
</file>